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56" userDrawn="1">
          <p15:clr>
            <a:srgbClr val="A4A3A4"/>
          </p15:clr>
        </p15:guide>
        <p15:guide id="2" pos="417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9555" autoAdjust="0"/>
    <p:restoredTop sz="81010" autoAdjust="0"/>
  </p:normalViewPr>
  <p:slideViewPr>
    <p:cSldViewPr snapToGrid="0" showGuides="1">
      <p:cViewPr>
        <p:scale>
          <a:sx n="82" d="100"/>
          <a:sy n="82" d="100"/>
        </p:scale>
        <p:origin x="-390" y="-288"/>
      </p:cViewPr>
      <p:guideLst>
        <p:guide orient="horz" pos="2856"/>
        <p:guide pos="4176"/>
      </p:guideLst>
    </p:cSldViewPr>
  </p:slideViewPr>
  <p:notesTextViewPr>
    <p:cViewPr>
      <p:scale>
        <a:sx n="155" d="100"/>
        <a:sy n="155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03803E1-CBFC-4ABA-8C94-A831948757F3}" type="datetimeFigureOut">
              <a:rPr lang="en-US" smtClean="0"/>
              <a:t>6/30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65DA221-0BAC-4643-A50D-3CB3ACB068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3682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r>
              <a:rPr lang="en-US" sz="1400" b="1" kern="1200" dirty="0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S4 Fig.</a:t>
            </a:r>
            <a:r>
              <a:rPr lang="en-US" sz="1400" kern="1200" dirty="0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sz="1400" i="1" kern="1200" dirty="0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Tgm9</a:t>
            </a:r>
            <a:r>
              <a:rPr lang="en-US" sz="1400" kern="1200" dirty="0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 caused the insertion mutation in the </a:t>
            </a:r>
            <a:r>
              <a:rPr lang="en-US" sz="1400" i="1" kern="1200" dirty="0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GmMER3</a:t>
            </a:r>
            <a:r>
              <a:rPr lang="en-US" sz="1400" kern="1200" dirty="0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 gene of the </a:t>
            </a:r>
            <a:r>
              <a:rPr lang="en-US" sz="1400" i="1" kern="1200" dirty="0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mer3</a:t>
            </a:r>
            <a:r>
              <a:rPr lang="en-US" sz="1400" kern="1200" dirty="0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 mutant</a:t>
            </a:r>
            <a:r>
              <a:rPr lang="en-US" sz="1400" i="1" kern="1200" dirty="0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.</a:t>
            </a:r>
            <a:r>
              <a:rPr lang="en-US" sz="1400" kern="1200" dirty="0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 Transposon insertion sequence from the </a:t>
            </a:r>
            <a:r>
              <a:rPr lang="en-US" sz="1400" i="1" kern="1200" dirty="0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GmMER3</a:t>
            </a:r>
            <a:r>
              <a:rPr lang="en-US" sz="1400" kern="1200" dirty="0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 gene was amplified by conducting long-range PCR and compared to both </a:t>
            </a:r>
            <a:r>
              <a:rPr lang="en-US" sz="1400" i="1" kern="1200" dirty="0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Tgm9</a:t>
            </a:r>
            <a:r>
              <a:rPr lang="en-US" sz="1400" kern="1200" dirty="0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 and </a:t>
            </a:r>
            <a:r>
              <a:rPr lang="en-US" sz="1400" i="1" kern="1200" dirty="0" err="1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Tgmt</a:t>
            </a:r>
            <a:r>
              <a:rPr lang="en-US" sz="1400" i="1" kern="1200" dirty="0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*</a:t>
            </a:r>
            <a:r>
              <a:rPr lang="en-US" sz="1400" kern="1200" dirty="0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, the two highly similar transposons characterized from soybean. A) The orientation of the </a:t>
            </a:r>
            <a:r>
              <a:rPr lang="en-US" sz="1400" i="1" kern="1200" dirty="0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Tgm9</a:t>
            </a:r>
            <a:r>
              <a:rPr lang="en-US" sz="1400" kern="1200" dirty="0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 insertion in the </a:t>
            </a:r>
            <a:r>
              <a:rPr lang="en-US" sz="1400" i="1" kern="1200" dirty="0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MER3</a:t>
            </a:r>
            <a:r>
              <a:rPr lang="en-US" sz="1400" kern="1200" dirty="0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 gene and primers used for nested PCR and sequencing are shown. B) First PCR product was amplified using primers 1 and 2. The amplified PCR product was 2,823 </a:t>
            </a:r>
            <a:r>
              <a:rPr lang="en-US" sz="1400" kern="1200" dirty="0" err="1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bp.</a:t>
            </a:r>
            <a:r>
              <a:rPr lang="en-US" sz="1400" kern="1200" dirty="0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 C) The nested PCR product was amplified using primers 3 and 4. The amplified PCR product was 2,758 </a:t>
            </a:r>
            <a:r>
              <a:rPr lang="en-US" sz="1400" kern="1200" dirty="0" err="1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bp.</a:t>
            </a:r>
            <a:r>
              <a:rPr lang="en-US" sz="1400" kern="1200" dirty="0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 Primer 3 was used for sequencing the PCR product represented by the dashed line X. Primer 4 was used to sequence the PCR product and produced sequence represented by the dashed line Y. D) Sequence from primer 3 matched the </a:t>
            </a:r>
            <a:r>
              <a:rPr lang="en-US" sz="1400" i="1" kern="1200" dirty="0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MER3</a:t>
            </a:r>
            <a:r>
              <a:rPr lang="en-US" sz="1400" kern="1200" dirty="0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 gene and the start of the 5’ end of the </a:t>
            </a:r>
            <a:r>
              <a:rPr lang="en-US" sz="1400" i="1" kern="1200" dirty="0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Tgm9</a:t>
            </a:r>
            <a:r>
              <a:rPr lang="en-US" sz="1400" kern="1200" dirty="0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 transposon sequence shown with the red font. E) Sequence from primer 4 aligned to the </a:t>
            </a:r>
            <a:r>
              <a:rPr lang="en-US" sz="1400" i="1" kern="1200" dirty="0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Tgm9</a:t>
            </a:r>
            <a:r>
              <a:rPr lang="en-US" sz="1400" kern="1200" dirty="0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 and </a:t>
            </a:r>
            <a:r>
              <a:rPr lang="en-US" sz="1400" i="1" kern="1200" dirty="0" err="1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Tgmt</a:t>
            </a:r>
            <a:r>
              <a:rPr lang="en-US" sz="1400" i="1" kern="1200" dirty="0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*</a:t>
            </a:r>
            <a:r>
              <a:rPr lang="en-US" sz="1400" kern="1200" dirty="0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. The PCR product matches the </a:t>
            </a:r>
            <a:r>
              <a:rPr lang="en-US" sz="1400" i="1" kern="1200" dirty="0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Tgm9</a:t>
            </a:r>
            <a:r>
              <a:rPr lang="en-US" sz="1400" kern="1200" dirty="0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 sequence perfectly. Polymorphic nucleotides between the insertion sequence and </a:t>
            </a:r>
            <a:r>
              <a:rPr lang="en-US" sz="1400" i="1" kern="1200" dirty="0" err="1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Tgmt</a:t>
            </a:r>
            <a:r>
              <a:rPr lang="en-US" sz="1400" i="1" kern="1200" dirty="0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* </a:t>
            </a:r>
            <a:r>
              <a:rPr lang="en-US" sz="1400" kern="1200" dirty="0" smtClean="0">
                <a:solidFill>
                  <a:schemeClr val="tx1"/>
                </a:solidFill>
                <a:effectLst/>
                <a:latin typeface="Times New Roman" charset="0"/>
                <a:ea typeface="Times New Roman" charset="0"/>
                <a:cs typeface="Times New Roman" charset="0"/>
              </a:rPr>
              <a:t>sequence are shown in red font.</a:t>
            </a:r>
            <a:endParaRPr lang="en-US" sz="1400" kern="1200" dirty="0">
              <a:solidFill>
                <a:schemeClr val="tx1"/>
              </a:solidFill>
              <a:effectLst/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65DA221-0BAC-4643-A50D-3CB3ACB0688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11622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0C5925-4BEF-4819-A3F0-8AC43AE60B08}" type="datetimeFigureOut">
              <a:rPr lang="en-US" smtClean="0"/>
              <a:t>6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C0DD4-5AD2-4D0C-AF4A-DD27DDB4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09019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0C5925-4BEF-4819-A3F0-8AC43AE60B08}" type="datetimeFigureOut">
              <a:rPr lang="en-US" smtClean="0"/>
              <a:t>6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C0DD4-5AD2-4D0C-AF4A-DD27DDB4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18743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0C5925-4BEF-4819-A3F0-8AC43AE60B08}" type="datetimeFigureOut">
              <a:rPr lang="en-US" smtClean="0"/>
              <a:t>6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C0DD4-5AD2-4D0C-AF4A-DD27DDB4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23465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0C5925-4BEF-4819-A3F0-8AC43AE60B08}" type="datetimeFigureOut">
              <a:rPr lang="en-US" smtClean="0"/>
              <a:t>6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C0DD4-5AD2-4D0C-AF4A-DD27DDB4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08972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0C5925-4BEF-4819-A3F0-8AC43AE60B08}" type="datetimeFigureOut">
              <a:rPr lang="en-US" smtClean="0"/>
              <a:t>6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C0DD4-5AD2-4D0C-AF4A-DD27DDB4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23508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0C5925-4BEF-4819-A3F0-8AC43AE60B08}" type="datetimeFigureOut">
              <a:rPr lang="en-US" smtClean="0"/>
              <a:t>6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C0DD4-5AD2-4D0C-AF4A-DD27DDB4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67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0C5925-4BEF-4819-A3F0-8AC43AE60B08}" type="datetimeFigureOut">
              <a:rPr lang="en-US" smtClean="0"/>
              <a:t>6/3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C0DD4-5AD2-4D0C-AF4A-DD27DDB4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46243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0C5925-4BEF-4819-A3F0-8AC43AE60B08}" type="datetimeFigureOut">
              <a:rPr lang="en-US" smtClean="0"/>
              <a:t>6/3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C0DD4-5AD2-4D0C-AF4A-DD27DDB4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51723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0C5925-4BEF-4819-A3F0-8AC43AE60B08}" type="datetimeFigureOut">
              <a:rPr lang="en-US" smtClean="0"/>
              <a:t>6/3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C0DD4-5AD2-4D0C-AF4A-DD27DDB4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18100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0C5925-4BEF-4819-A3F0-8AC43AE60B08}" type="datetimeFigureOut">
              <a:rPr lang="en-US" smtClean="0"/>
              <a:t>6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C0DD4-5AD2-4D0C-AF4A-DD27DDB4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56156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0C5925-4BEF-4819-A3F0-8AC43AE60B08}" type="datetimeFigureOut">
              <a:rPr lang="en-US" smtClean="0"/>
              <a:t>6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C0DD4-5AD2-4D0C-AF4A-DD27DDB4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01563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0C5925-4BEF-4819-A3F0-8AC43AE60B08}" type="datetimeFigureOut">
              <a:rPr lang="en-US" smtClean="0"/>
              <a:t>6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7C0DD4-5AD2-4D0C-AF4A-DD27DDB4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39669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8" name="Straight Connector 7"/>
          <p:cNvCxnSpPr/>
          <p:nvPr/>
        </p:nvCxnSpPr>
        <p:spPr>
          <a:xfrm flipH="1" flipV="1">
            <a:off x="1600678" y="457202"/>
            <a:ext cx="3435687" cy="1266823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/>
          <p:cNvSpPr txBox="1"/>
          <p:nvPr/>
        </p:nvSpPr>
        <p:spPr>
          <a:xfrm>
            <a:off x="1079850" y="1325731"/>
            <a:ext cx="3428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1</a:t>
            </a:r>
            <a:endParaRPr lang="en-US" sz="1400" dirty="0"/>
          </a:p>
        </p:txBody>
      </p:sp>
      <p:sp>
        <p:nvSpPr>
          <p:cNvPr id="45" name="TextBox 44"/>
          <p:cNvSpPr txBox="1"/>
          <p:nvPr/>
        </p:nvSpPr>
        <p:spPr>
          <a:xfrm>
            <a:off x="3713401" y="595000"/>
            <a:ext cx="3428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2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1532615" y="1315681"/>
            <a:ext cx="3428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3</a:t>
            </a:r>
            <a:endParaRPr lang="en-US" sz="1400" dirty="0"/>
          </a:p>
        </p:txBody>
      </p:sp>
      <p:sp>
        <p:nvSpPr>
          <p:cNvPr id="50" name="TextBox 49"/>
          <p:cNvSpPr txBox="1"/>
          <p:nvPr/>
        </p:nvSpPr>
        <p:spPr>
          <a:xfrm>
            <a:off x="3367567" y="595520"/>
            <a:ext cx="3428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</a:t>
            </a:r>
          </a:p>
        </p:txBody>
      </p:sp>
      <p:cxnSp>
        <p:nvCxnSpPr>
          <p:cNvPr id="72" name="Elbow Connector 71"/>
          <p:cNvCxnSpPr/>
          <p:nvPr/>
        </p:nvCxnSpPr>
        <p:spPr>
          <a:xfrm flipV="1">
            <a:off x="692053" y="1554524"/>
            <a:ext cx="724582" cy="200024"/>
          </a:xfrm>
          <a:prstGeom prst="bentConnector3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Elbow Connector 72"/>
          <p:cNvCxnSpPr/>
          <p:nvPr/>
        </p:nvCxnSpPr>
        <p:spPr>
          <a:xfrm flipV="1">
            <a:off x="1150932" y="1553436"/>
            <a:ext cx="724582" cy="200024"/>
          </a:xfrm>
          <a:prstGeom prst="bentConnector3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Elbow Connector 73"/>
          <p:cNvCxnSpPr/>
          <p:nvPr/>
        </p:nvCxnSpPr>
        <p:spPr>
          <a:xfrm rot="10800000" flipV="1">
            <a:off x="3303068" y="464843"/>
            <a:ext cx="603286" cy="195262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Elbow Connector 74"/>
          <p:cNvCxnSpPr/>
          <p:nvPr/>
        </p:nvCxnSpPr>
        <p:spPr>
          <a:xfrm rot="10800000" flipV="1">
            <a:off x="3653262" y="464844"/>
            <a:ext cx="603286" cy="195262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Rectangle 1"/>
          <p:cNvSpPr>
            <a:spLocks noChangeArrowheads="1"/>
          </p:cNvSpPr>
          <p:nvPr/>
        </p:nvSpPr>
        <p:spPr bwMode="auto">
          <a:xfrm>
            <a:off x="519905" y="4741760"/>
            <a:ext cx="4353689" cy="1846659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104742" tIns="0" rIns="104742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CR   ATGCAGTCATATATTCTTTACGGTGGTATGAAAGGAATCTATATATTGTTCTGGGATTTG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MER3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ATGCAGTCATATATTCTTTACGGTGGTATGAAAGGAATCTATATATTGTTCTGGGATTTG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800" dirty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r>
              <a:rPr lang="en-US" altLang="en-US" sz="8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************************************************************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rgbClr val="222222"/>
              </a:solidFill>
              <a:effectLst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CR   GCTAAATAATAATTCTTACTGGAAAGTGATTGCAATCCCATGCACCTGAATTAGAATTTC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MER3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GCTAAATAATAATTCTTACTGGAAAGTGATTGCAATCCCATGCACCTGAATTAGAATTTC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************************************************************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rgbClr val="222222"/>
              </a:solidFill>
              <a:effectLst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CR   AAATTGGTAGATATGTGACTTTTAGAAAATGGCTTTCCTAGTAGTTGGTTATCACAATGG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MER3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AAATTGGTAGATATGTGACTTTTAGAAAATGGCTTTCCTAGTAGTTGGTTATCACAATGG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************************************************************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rgbClr val="222222"/>
              </a:solidFill>
              <a:effectLst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CR   TGGGCTTTGCCTCAAAGATCGAAGTATTGTGGAAGGCCT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C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ACTACTAGAATAATGTTTTT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MER3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TGGGCTTTGCCTCAAAGATCGAAGTATTGTGGAAGGCCT---------------------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***************************************                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83" name="Rectangle 1"/>
          <p:cNvSpPr>
            <a:spLocks noChangeArrowheads="1"/>
          </p:cNvSpPr>
          <p:nvPr/>
        </p:nvSpPr>
        <p:spPr bwMode="auto">
          <a:xfrm>
            <a:off x="7197917" y="1417"/>
            <a:ext cx="4292775" cy="6894195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104742" tIns="0" rIns="104742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1" u="none" strike="noStrike" cap="none" normalizeH="0" baseline="0" dirty="0" err="1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gmt</a:t>
            </a:r>
            <a:r>
              <a:rPr kumimoji="0" lang="en-US" altLang="en-US" sz="8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*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AACAAACCATAACTAGAGAAAAAACTAGA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C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CACAAAAAGTAAGAAATAAAAATGCTAAA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gm9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AACAAACCATAACTAGAGAAAAAACTAGA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C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CACAAAAAGTAAGAAATAAAAATGCTAAA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800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CR</a:t>
            </a:r>
            <a:r>
              <a:rPr lang="en-US" altLang="en-US" sz="800" i="1" dirty="0" smtClean="0">
                <a:solidFill>
                  <a:srgbClr val="222222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r>
              <a:rPr kumimoji="0" lang="en-US" altLang="en-US" sz="8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AACAAACCATAACTAGAGAAAAAACTAGA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C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CACAAAAAGTAAGAAATAAAAATGCTAAA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*****************************.******************************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1" u="none" strike="noStrike" cap="none" normalizeH="0" baseline="0" dirty="0" err="1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gmt</a:t>
            </a:r>
            <a:r>
              <a:rPr kumimoji="0" lang="en-US" altLang="en-US" sz="8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*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AAAATGCAATTACAGGTTACCTTAGAAAATGAAGGTCTGATATGTGCCTCTTAATTTTCA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gm9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AAAATGCAATTACAGGTTACCTTAGAAAATGAAGGTCTGATATGTGCCTCTTAATTTTCA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CR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AAAATGCAATTACAGGTTACCTTAGAAAATGAAGGTCTGATATGTGCCTCTTAATTTTCA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************************************************************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1" u="none" strike="noStrike" cap="none" normalizeH="0" baseline="0" dirty="0" err="1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gmt</a:t>
            </a:r>
            <a:r>
              <a:rPr kumimoji="0" lang="en-US" altLang="en-US" sz="8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*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ACAACAGCTAACATGTAATCCGCAACGCTAGTTTTGCAGGCTGCAAAAATAATGTAGAAC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gm9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ACAACAGCTAACATGTAATCCGCAACGCTAGTTTTGCAGGCTGCAAAAATAATGTAGAAC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CR</a:t>
            </a:r>
            <a:r>
              <a:rPr kumimoji="0" lang="en-US" altLang="en-US" sz="8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ACAACAGCTAACATGTAATCCGCAACGCTAGTTTTGCAGGCTGCAAAAATAATGTAGAAC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************************************************************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1" u="none" strike="noStrike" cap="none" normalizeH="0" baseline="0" dirty="0" err="1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gmt</a:t>
            </a:r>
            <a:r>
              <a:rPr kumimoji="0" lang="en-US" altLang="en-US" sz="8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*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TGCAATGAAGTTCAACATGTATAGCCCTTTTCCTTTCTTAATGTGGAGATGGATAAATAA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gm9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TGCAATGAAGTTCAACATGTATAGCCCTTTTCCTTTCTTAATGTGGAGATGGATAAATAA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CR</a:t>
            </a:r>
            <a:r>
              <a:rPr kumimoji="0" lang="en-US" altLang="en-US" sz="8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TGCAATGAAGTTCAACATGTATAGCCCTTTTCCTTTCTTAATGTGGAGATGGATAAATAA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************************************************************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1" u="none" strike="noStrike" cap="none" normalizeH="0" baseline="0" dirty="0" err="1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gmt</a:t>
            </a:r>
            <a:r>
              <a:rPr kumimoji="0" lang="en-US" altLang="en-US" sz="8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*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ATTGCTAAAATGA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C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ATGTTCGAGAAAAACTAACCTAAGATCAATTCAAAGAGTAATGAT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gm9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ATTGCTAAAATGA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C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ATGTTCGAGAAAAACTAACCTAAGATCAATTCAAAGAGTAATGAT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CR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ATTGCTAAAATGA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C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ATGTTCGAGAAAAACTAACCTAAGATCAATTCAAAGAGTAATGAT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************* **********************************************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1" u="none" strike="noStrike" cap="none" normalizeH="0" baseline="0" dirty="0" err="1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gmt</a:t>
            </a:r>
            <a:r>
              <a:rPr kumimoji="0" lang="en-US" altLang="en-US" sz="8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*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ACATTTTTTCTGTCTAATTAGCAAAGAACTAATTATAAATTATATAGAGGGTAATGAGCA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gm9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ACATTTTTTCTGTCTAATTAGCAAAGAACTAATTATAAATTATATAGAGGGTAATGAGCA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CR</a:t>
            </a:r>
            <a:r>
              <a:rPr kumimoji="0" lang="en-US" altLang="en-US" sz="800" b="0" i="1" u="none" strike="noStrike" cap="none" normalizeH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ACATTTTTTCTGTCTAATTAGCAAAGAACTAATTATAAATTATATAGAGGGTAATGAGCA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************************************************************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1" u="none" strike="noStrike" cap="none" normalizeH="0" baseline="0" dirty="0" err="1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gmt</a:t>
            </a:r>
            <a:r>
              <a:rPr kumimoji="0" lang="en-US" altLang="en-US" sz="8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*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AAGACATCGAGTTAGAAAATGATCCATCAGTTGCATATATAT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C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AAACAAGGGATTCTAA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gm9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AAGACATCGAGTTAGAAAATGATCCATCAGTTGCATATATAT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C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AAACAAGGGATTCTAA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CR</a:t>
            </a:r>
            <a:r>
              <a:rPr kumimoji="0" lang="en-US" altLang="en-US" sz="8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AAGACATCGAGTTAGAAAATGATCCATCAGTTGCATATATAT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C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AAACAAGGGATTCTAA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******************************************.*****************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1" u="none" strike="noStrike" cap="none" normalizeH="0" baseline="0" dirty="0" err="1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gmt</a:t>
            </a:r>
            <a:r>
              <a:rPr kumimoji="0" lang="en-US" altLang="en-US" sz="8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*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AGTATTATTGTATGCTTGGTTTGAAGAAAGGGAGCAAAATTGAAAATGAATGAAGCAAAT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gm9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AGTATTATTGTATGCTTGGTTTGAAGAAAGGGAGCAAAATTGAAAATGAATGAAGCAAAT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CR</a:t>
            </a:r>
            <a:r>
              <a:rPr kumimoji="0" lang="en-US" altLang="en-US" sz="8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AGTATTATTGTATGCTTGGTTTGAAGAAAGGGAGCAAAATTGAAAATGAATGAAGCAAAT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************************************************************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1" u="none" strike="noStrike" cap="none" normalizeH="0" baseline="0" dirty="0" err="1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gmt</a:t>
            </a:r>
            <a:r>
              <a:rPr kumimoji="0" lang="en-US" altLang="en-US" sz="8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*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CTCTCAAAAGTGATTTTACAAAGGCACCTTGGTAGATTAGAATGTTAACTTTATCTTTCT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gm9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CTCTCAAAAGTGATTTTACAAAGGCACCTTGGTAGATTAGAATGTTAACTTTATCTTTCT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CR</a:t>
            </a:r>
            <a:r>
              <a:rPr kumimoji="0" lang="en-US" altLang="en-US" sz="8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CTCTCAAAAGTGATTTTACAAAGGCACCTTGGTAGATTAGAATGTTAACTTTATCTTTCT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************************************************************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1" u="none" strike="noStrike" cap="none" normalizeH="0" baseline="0" dirty="0" err="1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gmt</a:t>
            </a:r>
            <a:r>
              <a:rPr kumimoji="0" lang="en-US" altLang="en-US" sz="8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*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GATATAAATTGGAAAAACTATCTATTATAGATTCACTGCACTATTTTATTTTTGCCTGTT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gm9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GATATAAATTGGAAAAACTATCTATTATAGATTCACTGCACTATTTTATTTTTGCCTGTT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CR</a:t>
            </a:r>
            <a:r>
              <a:rPr kumimoji="0" lang="en-US" altLang="en-US" sz="8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GATATAAATTGGAAAAACTATCTATTATAGATTCACTGCACTATTTTATTTTTGCCTGTT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************************************************************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1" u="none" strike="noStrike" cap="none" normalizeH="0" baseline="0" dirty="0" err="1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gmt</a:t>
            </a:r>
            <a:r>
              <a:rPr kumimoji="0" lang="en-US" altLang="en-US" sz="8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*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ATTACTGGTTTATTGAAGTTTTGAGTGTTATGTCTCTGGAGTTACATGTTCTGTCAGCAA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gm9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ATTACTGGTTTATTGAAGTTTTGAGTGTTATGTCTCTGGAGTTACATGTTCTGTCAGCAA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CR</a:t>
            </a:r>
            <a:r>
              <a:rPr kumimoji="0" lang="en-US" altLang="en-US" sz="8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ATTACTGGTTTATTGAAGTTTTGAGTGTTATGTCTCTGGAGTTACATGTTCTGTCAGCAA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************************************************************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1" u="none" strike="noStrike" cap="none" normalizeH="0" baseline="0" dirty="0" err="1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gmt</a:t>
            </a:r>
            <a:r>
              <a:rPr kumimoji="0" lang="en-US" altLang="en-US" sz="8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*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AAAAATATTAAGGGAAACTGTTTATTTAAAATTTCCAACATTGTGTCTGGTGCTGTCTCA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gm9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AAAAATATTAAGGGAAACTGTTTATTTAAAATTTCCAACATTGTGTCTGGTGCTGTCTCA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CR</a:t>
            </a:r>
            <a:r>
              <a:rPr kumimoji="0" lang="en-US" altLang="en-US" sz="8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AAAAATATTAAGGGAAACTGTTTATTTAAAATTTCCAACATTGTGTCTGGTGCTGTCTCA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************************************************************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1" u="none" strike="noStrike" cap="none" normalizeH="0" baseline="0" dirty="0" err="1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gmt</a:t>
            </a:r>
            <a:r>
              <a:rPr kumimoji="0" lang="en-US" altLang="en-US" sz="8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*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TTGTAGTGGGTCAAAGAACTTGCTACTTTCTATCATCAGGTGGGTCTTTTTGTGTTATTA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gm9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TTGTAGTGGGTCAAAGAACTTGCTACTTTCTATCATCAGGTGGGTCTTTTTGTGTTATTA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CR</a:t>
            </a:r>
            <a:r>
              <a:rPr kumimoji="0" lang="en-US" altLang="en-US" sz="8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TTGTAGTGGGTCAAAGAACTTGCTACTTTCTATCATCAGGTGGGTCTTTTTGTGTTATTA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************************************************************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1" u="none" strike="noStrike" cap="none" normalizeH="0" baseline="0" dirty="0" err="1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gmt</a:t>
            </a:r>
            <a:r>
              <a:rPr kumimoji="0" lang="en-US" altLang="en-US" sz="8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*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GAGTTAGACTACTGATTTTT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C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AATTTTTAGTCATTTTTTTGAACATTTTGTACTA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gm9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GAGTTAGACTACTGATTTTT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C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AATTTTTAGTCATTTTTTTGAACATTTTGTACTA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CR</a:t>
            </a:r>
            <a:r>
              <a:rPr kumimoji="0" lang="en-US" altLang="en-US" sz="8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GAGTTAGACTACTGATTTTT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C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TTAATTTTTAGTCATTTTTTTGAACATTTTGTACTA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********************.***************************************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90" name="TextBox 89"/>
          <p:cNvSpPr txBox="1"/>
          <p:nvPr/>
        </p:nvSpPr>
        <p:spPr>
          <a:xfrm>
            <a:off x="1495226" y="82603"/>
            <a:ext cx="4451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5’</a:t>
            </a:r>
            <a:endParaRPr lang="en-US" dirty="0"/>
          </a:p>
        </p:txBody>
      </p:sp>
      <p:sp>
        <p:nvSpPr>
          <p:cNvPr id="91" name="TextBox 90"/>
          <p:cNvSpPr txBox="1"/>
          <p:nvPr/>
        </p:nvSpPr>
        <p:spPr>
          <a:xfrm>
            <a:off x="145268" y="15889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92" name="TextBox 91"/>
          <p:cNvSpPr txBox="1"/>
          <p:nvPr/>
        </p:nvSpPr>
        <p:spPr>
          <a:xfrm>
            <a:off x="124520" y="2084397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93" name="TextBox 92"/>
          <p:cNvSpPr txBox="1"/>
          <p:nvPr/>
        </p:nvSpPr>
        <p:spPr>
          <a:xfrm>
            <a:off x="111778" y="3226908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sp>
        <p:nvSpPr>
          <p:cNvPr id="94" name="TextBox 93"/>
          <p:cNvSpPr txBox="1"/>
          <p:nvPr/>
        </p:nvSpPr>
        <p:spPr>
          <a:xfrm>
            <a:off x="89083" y="4423349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D</a:t>
            </a:r>
            <a:endParaRPr lang="en-US" dirty="0"/>
          </a:p>
        </p:txBody>
      </p:sp>
      <p:sp>
        <p:nvSpPr>
          <p:cNvPr id="95" name="TextBox 94"/>
          <p:cNvSpPr txBox="1"/>
          <p:nvPr/>
        </p:nvSpPr>
        <p:spPr>
          <a:xfrm>
            <a:off x="6740717" y="15889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E</a:t>
            </a:r>
            <a:endParaRPr lang="en-US" dirty="0"/>
          </a:p>
        </p:txBody>
      </p:sp>
      <p:sp>
        <p:nvSpPr>
          <p:cNvPr id="96" name="TextBox 95"/>
          <p:cNvSpPr txBox="1"/>
          <p:nvPr/>
        </p:nvSpPr>
        <p:spPr>
          <a:xfrm>
            <a:off x="2489754" y="120971"/>
            <a:ext cx="10367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Tgm9</a:t>
            </a:r>
            <a:endParaRPr lang="en-US" dirty="0"/>
          </a:p>
        </p:txBody>
      </p:sp>
      <p:sp>
        <p:nvSpPr>
          <p:cNvPr id="97" name="TextBox 96"/>
          <p:cNvSpPr txBox="1"/>
          <p:nvPr/>
        </p:nvSpPr>
        <p:spPr>
          <a:xfrm>
            <a:off x="2543457" y="1824763"/>
            <a:ext cx="854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/>
              <a:t>MER3</a:t>
            </a:r>
            <a:endParaRPr lang="en-US" i="1" dirty="0"/>
          </a:p>
        </p:txBody>
      </p:sp>
      <p:sp>
        <p:nvSpPr>
          <p:cNvPr id="2" name="Rectangle 1"/>
          <p:cNvSpPr/>
          <p:nvPr/>
        </p:nvSpPr>
        <p:spPr>
          <a:xfrm>
            <a:off x="5507489" y="-377661"/>
            <a:ext cx="8066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charset="0"/>
                <a:ea typeface="Times New Roman" charset="0"/>
                <a:cs typeface="Times New Roman" charset="0"/>
              </a:rPr>
              <a:t>S4 Fig</a:t>
            </a:r>
            <a:endParaRPr lang="en-US" dirty="0"/>
          </a:p>
        </p:txBody>
      </p:sp>
      <p:cxnSp>
        <p:nvCxnSpPr>
          <p:cNvPr id="4" name="Straight Connector 3"/>
          <p:cNvCxnSpPr/>
          <p:nvPr/>
        </p:nvCxnSpPr>
        <p:spPr>
          <a:xfrm>
            <a:off x="1600678" y="478728"/>
            <a:ext cx="343568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/>
          <p:cNvCxnSpPr/>
          <p:nvPr/>
        </p:nvCxnSpPr>
        <p:spPr>
          <a:xfrm>
            <a:off x="652765" y="1765035"/>
            <a:ext cx="438912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/>
          <p:cNvCxnSpPr/>
          <p:nvPr/>
        </p:nvCxnSpPr>
        <p:spPr>
          <a:xfrm>
            <a:off x="652765" y="1859560"/>
            <a:ext cx="438912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/>
          <p:cNvCxnSpPr/>
          <p:nvPr/>
        </p:nvCxnSpPr>
        <p:spPr>
          <a:xfrm>
            <a:off x="652766" y="2690377"/>
            <a:ext cx="438912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>
            <a:off x="652766" y="2784902"/>
            <a:ext cx="438912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61"/>
          <p:cNvSpPr txBox="1"/>
          <p:nvPr/>
        </p:nvSpPr>
        <p:spPr>
          <a:xfrm>
            <a:off x="1081775" y="2253656"/>
            <a:ext cx="3428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1</a:t>
            </a:r>
            <a:endParaRPr lang="en-US" sz="1400" dirty="0"/>
          </a:p>
        </p:txBody>
      </p:sp>
      <p:sp>
        <p:nvSpPr>
          <p:cNvPr id="63" name="TextBox 62"/>
          <p:cNvSpPr txBox="1"/>
          <p:nvPr/>
        </p:nvSpPr>
        <p:spPr>
          <a:xfrm>
            <a:off x="1534540" y="2243606"/>
            <a:ext cx="3428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3</a:t>
            </a:r>
            <a:endParaRPr lang="en-US" sz="1400" dirty="0"/>
          </a:p>
        </p:txBody>
      </p:sp>
      <p:cxnSp>
        <p:nvCxnSpPr>
          <p:cNvPr id="64" name="Elbow Connector 63"/>
          <p:cNvCxnSpPr/>
          <p:nvPr/>
        </p:nvCxnSpPr>
        <p:spPr>
          <a:xfrm flipV="1">
            <a:off x="693978" y="2482449"/>
            <a:ext cx="724582" cy="200024"/>
          </a:xfrm>
          <a:prstGeom prst="bentConnector3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Elbow Connector 64"/>
          <p:cNvCxnSpPr/>
          <p:nvPr/>
        </p:nvCxnSpPr>
        <p:spPr>
          <a:xfrm flipV="1">
            <a:off x="1152857" y="2481361"/>
            <a:ext cx="724582" cy="200024"/>
          </a:xfrm>
          <a:prstGeom prst="bentConnector3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65"/>
          <p:cNvSpPr txBox="1"/>
          <p:nvPr/>
        </p:nvSpPr>
        <p:spPr>
          <a:xfrm>
            <a:off x="4444551" y="2923500"/>
            <a:ext cx="3428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2</a:t>
            </a:r>
          </a:p>
        </p:txBody>
      </p:sp>
      <p:sp>
        <p:nvSpPr>
          <p:cNvPr id="69" name="TextBox 68"/>
          <p:cNvSpPr txBox="1"/>
          <p:nvPr/>
        </p:nvSpPr>
        <p:spPr>
          <a:xfrm>
            <a:off x="4098717" y="2924020"/>
            <a:ext cx="3428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</a:t>
            </a:r>
          </a:p>
        </p:txBody>
      </p:sp>
      <p:cxnSp>
        <p:nvCxnSpPr>
          <p:cNvPr id="70" name="Elbow Connector 69"/>
          <p:cNvCxnSpPr/>
          <p:nvPr/>
        </p:nvCxnSpPr>
        <p:spPr>
          <a:xfrm rot="10800000" flipV="1">
            <a:off x="4034218" y="2793343"/>
            <a:ext cx="603286" cy="195262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Elbow Connector 70"/>
          <p:cNvCxnSpPr/>
          <p:nvPr/>
        </p:nvCxnSpPr>
        <p:spPr>
          <a:xfrm rot="10800000" flipV="1">
            <a:off x="4384412" y="2793344"/>
            <a:ext cx="603286" cy="195262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Connector 98"/>
          <p:cNvCxnSpPr/>
          <p:nvPr/>
        </p:nvCxnSpPr>
        <p:spPr>
          <a:xfrm>
            <a:off x="689416" y="3687752"/>
            <a:ext cx="438912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Connector 99"/>
          <p:cNvCxnSpPr/>
          <p:nvPr/>
        </p:nvCxnSpPr>
        <p:spPr>
          <a:xfrm>
            <a:off x="689416" y="3782277"/>
            <a:ext cx="438912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TextBox 101"/>
          <p:cNvSpPr txBox="1"/>
          <p:nvPr/>
        </p:nvSpPr>
        <p:spPr>
          <a:xfrm>
            <a:off x="1571190" y="3240981"/>
            <a:ext cx="3428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3</a:t>
            </a:r>
            <a:endParaRPr lang="en-US" sz="1400" dirty="0"/>
          </a:p>
        </p:txBody>
      </p:sp>
      <p:cxnSp>
        <p:nvCxnSpPr>
          <p:cNvPr id="104" name="Elbow Connector 103"/>
          <p:cNvCxnSpPr/>
          <p:nvPr/>
        </p:nvCxnSpPr>
        <p:spPr>
          <a:xfrm flipV="1">
            <a:off x="1189507" y="3478736"/>
            <a:ext cx="724582" cy="200024"/>
          </a:xfrm>
          <a:prstGeom prst="bentConnector3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TextBox 105"/>
          <p:cNvSpPr txBox="1"/>
          <p:nvPr/>
        </p:nvSpPr>
        <p:spPr>
          <a:xfrm>
            <a:off x="4135367" y="3921395"/>
            <a:ext cx="3428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4</a:t>
            </a:r>
          </a:p>
        </p:txBody>
      </p:sp>
      <p:cxnSp>
        <p:nvCxnSpPr>
          <p:cNvPr id="107" name="Elbow Connector 106"/>
          <p:cNvCxnSpPr/>
          <p:nvPr/>
        </p:nvCxnSpPr>
        <p:spPr>
          <a:xfrm rot="10800000" flipV="1">
            <a:off x="4070868" y="3779143"/>
            <a:ext cx="603286" cy="195262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>
            <a:off x="1551798" y="3598610"/>
            <a:ext cx="991659" cy="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Connector 108"/>
          <p:cNvCxnSpPr/>
          <p:nvPr/>
        </p:nvCxnSpPr>
        <p:spPr>
          <a:xfrm>
            <a:off x="3359423" y="3889910"/>
            <a:ext cx="991659" cy="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1989753" y="3302803"/>
            <a:ext cx="304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X</a:t>
            </a:r>
            <a:endParaRPr lang="en-US" dirty="0"/>
          </a:p>
        </p:txBody>
      </p:sp>
      <p:sp>
        <p:nvSpPr>
          <p:cNvPr id="110" name="TextBox 109"/>
          <p:cNvSpPr txBox="1"/>
          <p:nvPr/>
        </p:nvSpPr>
        <p:spPr>
          <a:xfrm>
            <a:off x="3670895" y="3825747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Y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78463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9</TotalTime>
  <Words>391</Words>
  <Application>Microsoft Office PowerPoint</Application>
  <PresentationFormat>Custom</PresentationFormat>
  <Paragraphs>9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umbach, Jordan L [AGRON]</dc:creator>
  <cp:lastModifiedBy>Devinder Sandhu</cp:lastModifiedBy>
  <cp:revision>24</cp:revision>
  <dcterms:created xsi:type="dcterms:W3CDTF">2016-11-21T16:06:44Z</dcterms:created>
  <dcterms:modified xsi:type="dcterms:W3CDTF">2017-06-30T16:38:05Z</dcterms:modified>
</cp:coreProperties>
</file>